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963"/>
    <p:restoredTop sz="94713"/>
  </p:normalViewPr>
  <p:slideViewPr>
    <p:cSldViewPr snapToGrid="0" snapToObjects="1">
      <p:cViewPr varScale="1">
        <p:scale>
          <a:sx n="68" d="100"/>
          <a:sy n="68" d="100"/>
        </p:scale>
        <p:origin x="155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9F0532-8B7E-CE48-993A-6077FECB715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8C7068-3195-864D-BDB0-7E17389584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045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4763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0208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5032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406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554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665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086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842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123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760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001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681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810" y="545100"/>
            <a:ext cx="5260164" cy="526016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テキスト ボックス 1"/>
          <p:cNvSpPr txBox="1"/>
          <p:nvPr/>
        </p:nvSpPr>
        <p:spPr>
          <a:xfrm rot="16200000">
            <a:off x="4133974" y="1316081"/>
            <a:ext cx="5437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mRNAs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4133039" y="1885468"/>
            <a:ext cx="5837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lncRNAs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8313733" y="17576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1 Fig.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806335" y="5513637"/>
            <a:ext cx="77174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 Fig. Chromosomal (A01-A10) distribution of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ncRNA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mRNAs.</a:t>
            </a:r>
          </a:p>
          <a:p>
            <a:pPr algn="just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2 FPKM of mRNAs represented in blue (positive values) and orange (negative values), and lncRNAs in green (positive values) and pink (negative values)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137118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53</TotalTime>
  <Words>49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Yu Gothic</vt:lpstr>
      <vt:lpstr>Arial</vt:lpstr>
      <vt:lpstr>Calibri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moto</dc:creator>
  <cp:lastModifiedBy>Vijayakumar A478</cp:lastModifiedBy>
  <cp:revision>103</cp:revision>
  <cp:lastPrinted>2020-09-24T05:48:32Z</cp:lastPrinted>
  <dcterms:created xsi:type="dcterms:W3CDTF">2019-06-11T01:58:39Z</dcterms:created>
  <dcterms:modified xsi:type="dcterms:W3CDTF">2021-03-24T01:10:54Z</dcterms:modified>
</cp:coreProperties>
</file>